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14914-E397-4AF2-8E68-F69E56E9AE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21A25-C18F-4B03-B133-74B90B33B8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D59C6-F8FB-4125-B745-EAD8FBC1E7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15B31-5B0D-4914-A97E-C2970EF041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EE66FA-9915-4ED2-890B-319C0A0469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3DA111-1986-4836-A3C8-08D83497E0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95C57-6CC5-491D-AF28-2EF72D04ED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053E0-94C8-4E63-AD90-147E2EEAFD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FF8DC-7B01-4EBF-9EFA-0185FC467E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CF896-BB65-4A64-A635-3089F347B9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FCDDA-9D65-4096-B8F3-2FB100A8CD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C25D75-EFE7-415E-AF49-95AD5DAB38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BD1C03-06CB-48AE-93AF-2E6F9669F1D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65"/>
          <p:cNvSpPr/>
          <p:nvPr/>
        </p:nvSpPr>
        <p:spPr>
          <a:xfrm>
            <a:off x="1847880" y="6365880"/>
            <a:ext cx="548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.  Networking of metabolic processes inside the cel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94"/>
          <p:cNvGrpSpPr/>
          <p:nvPr/>
        </p:nvGrpSpPr>
        <p:grpSpPr>
          <a:xfrm>
            <a:off x="1371600" y="609480"/>
            <a:ext cx="5486400" cy="5635800"/>
            <a:chOff x="1371600" y="609480"/>
            <a:chExt cx="5486400" cy="5635800"/>
          </a:xfrm>
        </p:grpSpPr>
        <p:grpSp>
          <p:nvGrpSpPr>
            <p:cNvPr id="43" name="Group 64"/>
            <p:cNvGrpSpPr/>
            <p:nvPr/>
          </p:nvGrpSpPr>
          <p:grpSpPr>
            <a:xfrm>
              <a:off x="1371600" y="609480"/>
              <a:ext cx="5486400" cy="5635800"/>
              <a:chOff x="1371600" y="609480"/>
              <a:chExt cx="5486400" cy="5635800"/>
            </a:xfrm>
          </p:grpSpPr>
          <p:grpSp>
            <p:nvGrpSpPr>
              <p:cNvPr id="44" name="Group 75"/>
              <p:cNvGrpSpPr/>
              <p:nvPr/>
            </p:nvGrpSpPr>
            <p:grpSpPr>
              <a:xfrm>
                <a:off x="1371600" y="609480"/>
                <a:ext cx="5486400" cy="5635800"/>
                <a:chOff x="1371600" y="609480"/>
                <a:chExt cx="5486400" cy="5635800"/>
              </a:xfrm>
            </p:grpSpPr>
            <p:sp>
              <p:nvSpPr>
                <p:cNvPr id="45" name="TextBox 201"/>
                <p:cNvSpPr/>
                <p:nvPr/>
              </p:nvSpPr>
              <p:spPr>
                <a:xfrm>
                  <a:off x="3429000" y="1436760"/>
                  <a:ext cx="7250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 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46" name="Straight Arrow Connector 202"/>
                <p:cNvCxnSpPr/>
                <p:nvPr/>
              </p:nvCxnSpPr>
              <p:spPr>
                <a:xfrm flipH="1">
                  <a:off x="2133000" y="977760"/>
                  <a:ext cx="2160" cy="41976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47" name="Straight Arrow Connector 203"/>
                <p:cNvCxnSpPr/>
                <p:nvPr/>
              </p:nvCxnSpPr>
              <p:spPr>
                <a:xfrm flipH="1">
                  <a:off x="3862080" y="977760"/>
                  <a:ext cx="2160" cy="41976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48" name="Straight Arrow Connector 204"/>
                <p:cNvCxnSpPr/>
                <p:nvPr/>
              </p:nvCxnSpPr>
              <p:spPr>
                <a:xfrm flipH="1">
                  <a:off x="5604840" y="977760"/>
                  <a:ext cx="1080" cy="41976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sp>
              <p:nvSpPr>
                <p:cNvPr id="49" name="TextBox 205"/>
                <p:cNvSpPr/>
                <p:nvPr/>
              </p:nvSpPr>
              <p:spPr>
                <a:xfrm>
                  <a:off x="1676160" y="1371240"/>
                  <a:ext cx="102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mino acids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TextBox 206"/>
                <p:cNvSpPr/>
                <p:nvPr/>
              </p:nvSpPr>
              <p:spPr>
                <a:xfrm>
                  <a:off x="5248440" y="1420920"/>
                  <a:ext cx="5695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 </a:t>
                  </a: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TG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51" name="Straight Arrow Connector 207"/>
                <p:cNvCxnSpPr/>
                <p:nvPr/>
              </p:nvCxnSpPr>
              <p:spPr>
                <a:xfrm>
                  <a:off x="3845520" y="3056040"/>
                  <a:ext cx="1080" cy="100872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52" name="Straight Arrow Connector 208"/>
                <p:cNvCxnSpPr/>
                <p:nvPr/>
              </p:nvCxnSpPr>
              <p:spPr>
                <a:xfrm flipH="1">
                  <a:off x="3863160" y="4422960"/>
                  <a:ext cx="1080" cy="33552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sp>
              <p:nvSpPr>
                <p:cNvPr id="53" name="TextBox 209"/>
                <p:cNvSpPr/>
                <p:nvPr/>
              </p:nvSpPr>
              <p:spPr>
                <a:xfrm>
                  <a:off x="3377160" y="2825640"/>
                  <a:ext cx="828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    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TextBox 210"/>
                <p:cNvSpPr/>
                <p:nvPr/>
              </p:nvSpPr>
              <p:spPr>
                <a:xfrm>
                  <a:off x="3429000" y="4116600"/>
                  <a:ext cx="6732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TextBox 211"/>
                <p:cNvSpPr/>
                <p:nvPr/>
              </p:nvSpPr>
              <p:spPr>
                <a:xfrm>
                  <a:off x="1371600" y="4876920"/>
                  <a:ext cx="1002240" cy="9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Blood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mino acid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lucos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FF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O2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56" name="Straight Arrow Connector 212"/>
                <p:cNvCxnSpPr/>
                <p:nvPr/>
              </p:nvCxnSpPr>
              <p:spPr>
                <a:xfrm>
                  <a:off x="2361960" y="5181840"/>
                  <a:ext cx="729360" cy="1656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57" name="Straight Arrow Connector 213"/>
                <p:cNvCxnSpPr/>
                <p:nvPr/>
              </p:nvCxnSpPr>
              <p:spPr>
                <a:xfrm>
                  <a:off x="4419720" y="5775480"/>
                  <a:ext cx="288000" cy="32112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sp>
              <p:nvSpPr>
                <p:cNvPr id="58" name="TextBox 214"/>
                <p:cNvSpPr/>
                <p:nvPr/>
              </p:nvSpPr>
              <p:spPr>
                <a:xfrm>
                  <a:off x="4658760" y="5983920"/>
                  <a:ext cx="12085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2+H2O+ATP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TextBox 215"/>
                <p:cNvSpPr/>
                <p:nvPr/>
              </p:nvSpPr>
              <p:spPr>
                <a:xfrm>
                  <a:off x="4715280" y="5082840"/>
                  <a:ext cx="1033560" cy="5961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lucos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mino acids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FF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60" name="Straight Arrow Connector 216"/>
                <p:cNvCxnSpPr/>
                <p:nvPr/>
              </p:nvCxnSpPr>
              <p:spPr>
                <a:xfrm flipH="1" flipV="1">
                  <a:off x="4552200" y="5227560"/>
                  <a:ext cx="354600" cy="1008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sp>
              <p:nvSpPr>
                <p:cNvPr id="61" name="TextBox 217"/>
                <p:cNvSpPr/>
                <p:nvPr/>
              </p:nvSpPr>
              <p:spPr>
                <a:xfrm>
                  <a:off x="6001560" y="4959720"/>
                  <a:ext cx="776880" cy="763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uscl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lycoge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rote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TG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62" name="Straight Arrow Connector 218"/>
                <p:cNvCxnSpPr/>
                <p:nvPr/>
              </p:nvCxnSpPr>
              <p:spPr>
                <a:xfrm>
                  <a:off x="1976760" y="1648800"/>
                  <a:ext cx="1391040" cy="331380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headEnd len="med" type="arrow" w="med"/>
                  <a:tailEnd len="med" type="arrow" w="med"/>
                </a:ln>
              </p:spPr>
            </p:cxnSp>
            <p:sp>
              <p:nvSpPr>
                <p:cNvPr id="63" name="TextBox 219"/>
                <p:cNvSpPr/>
                <p:nvPr/>
              </p:nvSpPr>
              <p:spPr>
                <a:xfrm rot="4002600">
                  <a:off x="1820160" y="3309840"/>
                  <a:ext cx="16606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</a:t>
                  </a: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Thiamin, Niac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64" name="Straight Arrow Connector 220"/>
                <p:cNvCxnSpPr/>
                <p:nvPr/>
              </p:nvCxnSpPr>
              <p:spPr>
                <a:xfrm>
                  <a:off x="2238120" y="1617480"/>
                  <a:ext cx="1210320" cy="243288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headEnd len="med" type="arrow" w="med"/>
                  <a:tailEnd len="med" type="arrow" w="med"/>
                </a:ln>
              </p:spPr>
            </p:cxnSp>
            <p:cxnSp>
              <p:nvCxnSpPr>
                <p:cNvPr id="65" name="Straight Arrow Connector 221"/>
                <p:cNvCxnSpPr/>
                <p:nvPr/>
              </p:nvCxnSpPr>
              <p:spPr>
                <a:xfrm>
                  <a:off x="2391120" y="1649160"/>
                  <a:ext cx="1113120" cy="117072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headEnd len="med" type="arrow" w="med"/>
                  <a:tailEnd len="med" type="arrow" w="med"/>
                </a:ln>
              </p:spPr>
            </p:cxnSp>
            <p:sp>
              <p:nvSpPr>
                <p:cNvPr id="66" name="TextBox 222"/>
                <p:cNvSpPr/>
                <p:nvPr/>
              </p:nvSpPr>
              <p:spPr>
                <a:xfrm rot="3925800">
                  <a:off x="1712520" y="3107880"/>
                  <a:ext cx="21060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lucogenic Amino Acid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TextBox 223"/>
                <p:cNvSpPr/>
                <p:nvPr/>
              </p:nvSpPr>
              <p:spPr>
                <a:xfrm rot="3749400">
                  <a:off x="2201040" y="2983320"/>
                  <a:ext cx="1781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Ketogenic Amino acids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TextBox 224"/>
                <p:cNvSpPr/>
                <p:nvPr/>
              </p:nvSpPr>
              <p:spPr>
                <a:xfrm rot="2821800">
                  <a:off x="2327760" y="2295000"/>
                  <a:ext cx="13881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Vit.B12, B2, Biot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TextBox 225"/>
                <p:cNvSpPr/>
                <p:nvPr/>
              </p:nvSpPr>
              <p:spPr>
                <a:xfrm rot="2629800">
                  <a:off x="2523600" y="2109600"/>
                  <a:ext cx="11595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luconeogenesis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70" name="Straight Arrow Connector 226"/>
                <p:cNvCxnSpPr/>
                <p:nvPr/>
              </p:nvCxnSpPr>
              <p:spPr>
                <a:xfrm flipV="1">
                  <a:off x="4266720" y="1702800"/>
                  <a:ext cx="1183320" cy="111672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headEnd len="med" type="arrow" w="med"/>
                  <a:tailEnd len="med" type="arrow" w="med"/>
                </a:ln>
              </p:spPr>
            </p:cxnSp>
            <p:sp>
              <p:nvSpPr>
                <p:cNvPr id="71" name="TextBox 227"/>
                <p:cNvSpPr/>
                <p:nvPr/>
              </p:nvSpPr>
              <p:spPr>
                <a:xfrm rot="20631600">
                  <a:off x="4447080" y="1523160"/>
                  <a:ext cx="756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lycero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TextBox 228"/>
                <p:cNvSpPr/>
                <p:nvPr/>
              </p:nvSpPr>
              <p:spPr>
                <a:xfrm rot="18914400">
                  <a:off x="3818520" y="2320200"/>
                  <a:ext cx="21542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Riboflavin, Niacin, Biot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73" name="Straight Arrow Connector 229"/>
                <p:cNvCxnSpPr/>
                <p:nvPr/>
              </p:nvCxnSpPr>
              <p:spPr>
                <a:xfrm flipH="1" flipV="1">
                  <a:off x="5655600" y="1648800"/>
                  <a:ext cx="415080" cy="92448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sp>
              <p:nvSpPr>
                <p:cNvPr id="74" name="TextBox 230"/>
                <p:cNvSpPr/>
                <p:nvPr/>
              </p:nvSpPr>
              <p:spPr>
                <a:xfrm>
                  <a:off x="5334120" y="2550960"/>
                  <a:ext cx="1523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Free fatty Acids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TextBox 231"/>
                <p:cNvSpPr/>
                <p:nvPr/>
              </p:nvSpPr>
              <p:spPr>
                <a:xfrm>
                  <a:off x="3811320" y="3094920"/>
                  <a:ext cx="1294200" cy="763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Thiam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antothenic Acid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Niac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Biot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TextBox 232"/>
                <p:cNvSpPr/>
                <p:nvPr/>
              </p:nvSpPr>
              <p:spPr>
                <a:xfrm rot="19855800">
                  <a:off x="4854960" y="3375360"/>
                  <a:ext cx="11912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</a:t>
                  </a: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Lipogenesis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TextBox 233"/>
                <p:cNvSpPr/>
                <p:nvPr/>
              </p:nvSpPr>
              <p:spPr>
                <a:xfrm rot="19782600">
                  <a:off x="4881960" y="3110760"/>
                  <a:ext cx="8805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Lipolysis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78" name="Straight Arrow Connector 234"/>
                <p:cNvCxnSpPr/>
                <p:nvPr/>
              </p:nvCxnSpPr>
              <p:spPr>
                <a:xfrm>
                  <a:off x="3308760" y="2026800"/>
                  <a:ext cx="378360" cy="76572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headEnd len="med" type="arrow" w="med"/>
                  <a:tailEnd len="med" type="arrow" w="med"/>
                </a:ln>
              </p:spPr>
            </p:cxnSp>
            <p:sp>
              <p:nvSpPr>
                <p:cNvPr id="79" name="TextBox 235"/>
                <p:cNvSpPr/>
                <p:nvPr/>
              </p:nvSpPr>
              <p:spPr>
                <a:xfrm>
                  <a:off x="2895480" y="1760760"/>
                  <a:ext cx="6818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Lactat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TextBox 236"/>
                <p:cNvSpPr/>
                <p:nvPr/>
              </p:nvSpPr>
              <p:spPr>
                <a:xfrm>
                  <a:off x="3790800" y="2261880"/>
                  <a:ext cx="761760" cy="42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Thiam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Niac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81" name="Straight Arrow Connector 237"/>
                <p:cNvCxnSpPr/>
                <p:nvPr/>
              </p:nvCxnSpPr>
              <p:spPr>
                <a:xfrm flipH="1">
                  <a:off x="4204800" y="2824560"/>
                  <a:ext cx="1969200" cy="117684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82" name="Straight Arrow Connector 238"/>
                <p:cNvCxnSpPr/>
                <p:nvPr/>
              </p:nvCxnSpPr>
              <p:spPr>
                <a:xfrm flipV="1">
                  <a:off x="4343040" y="2909160"/>
                  <a:ext cx="1935720" cy="112932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83" name="Straight Arrow Connector 239"/>
                <p:cNvCxnSpPr/>
                <p:nvPr/>
              </p:nvCxnSpPr>
              <p:spPr>
                <a:xfrm flipH="1" flipV="1">
                  <a:off x="4419000" y="4182480"/>
                  <a:ext cx="872280" cy="684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sp>
              <p:nvSpPr>
                <p:cNvPr id="84" name="TextBox 240"/>
                <p:cNvSpPr/>
                <p:nvPr/>
              </p:nvSpPr>
              <p:spPr>
                <a:xfrm>
                  <a:off x="5257800" y="4057920"/>
                  <a:ext cx="7617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lcoho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TextBox 241"/>
                <p:cNvSpPr/>
                <p:nvPr/>
              </p:nvSpPr>
              <p:spPr>
                <a:xfrm>
                  <a:off x="5257800" y="4199040"/>
                  <a:ext cx="7261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Keton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Rounded Rectangle 242"/>
                <p:cNvSpPr/>
                <p:nvPr/>
              </p:nvSpPr>
              <p:spPr>
                <a:xfrm>
                  <a:off x="3349440" y="4081320"/>
                  <a:ext cx="990360" cy="3268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1fb917"/>
                </a:solidFill>
                <a:ln w="2556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Acetyl Co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87" name="Straight Arrow Connector 243"/>
                <p:cNvCxnSpPr/>
                <p:nvPr/>
              </p:nvCxnSpPr>
              <p:spPr>
                <a:xfrm flipH="1" flipV="1">
                  <a:off x="4419000" y="4342680"/>
                  <a:ext cx="872280" cy="684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sp>
              <p:nvSpPr>
                <p:cNvPr id="88" name="Oval 244"/>
                <p:cNvSpPr/>
                <p:nvPr/>
              </p:nvSpPr>
              <p:spPr>
                <a:xfrm>
                  <a:off x="3220920" y="4794480"/>
                  <a:ext cx="1260360" cy="1225440"/>
                </a:xfrm>
                <a:prstGeom prst="ellipse">
                  <a:avLst/>
                </a:prstGeom>
                <a:solidFill>
                  <a:srgbClr val="00b0f0"/>
                </a:solidFill>
                <a:ln w="2556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Krebs  Cycle  and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Electron Transport Syste</a:t>
                  </a:r>
                  <a:r>
                    <a:rPr b="0" lang="en-US" sz="12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Rounded Rectangle 245"/>
                <p:cNvSpPr/>
                <p:nvPr/>
              </p:nvSpPr>
              <p:spPr>
                <a:xfrm>
                  <a:off x="3468600" y="2819160"/>
                  <a:ext cx="761760" cy="2188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4f81bd"/>
                </a:solidFill>
                <a:ln w="2556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Pyruvat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Round Diagonal Corner Rectangle 246"/>
                <p:cNvSpPr/>
                <p:nvPr/>
              </p:nvSpPr>
              <p:spPr>
                <a:xfrm>
                  <a:off x="1769760" y="641160"/>
                  <a:ext cx="733320" cy="309240"/>
                </a:xfrm>
                <a:prstGeom prst="pie">
                  <a:avLst/>
                </a:prstGeom>
                <a:solidFill>
                  <a:srgbClr val="c624ba"/>
                </a:solidFill>
                <a:ln w="2556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Prote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Round Diagonal Corner Rectangle 247"/>
                <p:cNvSpPr/>
                <p:nvPr/>
              </p:nvSpPr>
              <p:spPr>
                <a:xfrm>
                  <a:off x="3281400" y="609480"/>
                  <a:ext cx="1137960" cy="341280"/>
                </a:xfrm>
                <a:prstGeom prst="pie">
                  <a:avLst/>
                </a:prstGeom>
                <a:solidFill>
                  <a:srgbClr val="cf1bad"/>
                </a:solidFill>
                <a:ln w="2556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Carbohydrat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Round Diagonal Corner Rectangle 248"/>
                <p:cNvSpPr/>
                <p:nvPr/>
              </p:nvSpPr>
              <p:spPr>
                <a:xfrm>
                  <a:off x="5303880" y="641160"/>
                  <a:ext cx="637920" cy="291960"/>
                </a:xfrm>
                <a:prstGeom prst="pie">
                  <a:avLst/>
                </a:prstGeom>
                <a:solidFill>
                  <a:srgbClr val="c3279a"/>
                </a:solidFill>
                <a:ln w="2556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Fat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TextBox 249"/>
                <p:cNvSpPr/>
                <p:nvPr/>
              </p:nvSpPr>
              <p:spPr>
                <a:xfrm>
                  <a:off x="3603960" y="1306080"/>
                  <a:ext cx="7264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ahoma"/>
                    </a:rPr>
                    <a:t>Glycoge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TextBox 250"/>
                <p:cNvSpPr/>
                <p:nvPr/>
              </p:nvSpPr>
              <p:spPr>
                <a:xfrm>
                  <a:off x="3517920" y="1962360"/>
                  <a:ext cx="640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lucos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95" name="Straight Arrow Connector 251"/>
                <p:cNvCxnSpPr/>
                <p:nvPr/>
              </p:nvCxnSpPr>
              <p:spPr>
                <a:xfrm flipV="1">
                  <a:off x="4076280" y="1801440"/>
                  <a:ext cx="402120" cy="24480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96" name="Straight Arrow Connector 252"/>
                <p:cNvCxnSpPr/>
                <p:nvPr/>
              </p:nvCxnSpPr>
              <p:spPr>
                <a:xfrm flipH="1">
                  <a:off x="3843000" y="1564920"/>
                  <a:ext cx="2160" cy="42120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97" name="Straight Arrow Connector 253"/>
                <p:cNvCxnSpPr/>
                <p:nvPr/>
              </p:nvCxnSpPr>
              <p:spPr>
                <a:xfrm flipH="1" flipV="1">
                  <a:off x="4548960" y="5386320"/>
                  <a:ext cx="354600" cy="1008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98" name="Straight Arrow Connector 254"/>
                <p:cNvCxnSpPr/>
                <p:nvPr/>
              </p:nvCxnSpPr>
              <p:spPr>
                <a:xfrm flipH="1" flipV="1">
                  <a:off x="4536360" y="5545080"/>
                  <a:ext cx="354600" cy="1008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99" name="Straight Arrow Connector 255"/>
                <p:cNvCxnSpPr/>
                <p:nvPr/>
              </p:nvCxnSpPr>
              <p:spPr>
                <a:xfrm flipH="1" flipV="1">
                  <a:off x="5673240" y="5240160"/>
                  <a:ext cx="354600" cy="864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100" name="Straight Arrow Connector 256"/>
                <p:cNvCxnSpPr/>
                <p:nvPr/>
              </p:nvCxnSpPr>
              <p:spPr>
                <a:xfrm flipH="1" flipV="1">
                  <a:off x="5679360" y="5573520"/>
                  <a:ext cx="353160" cy="1008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  <p:cxnSp>
              <p:nvCxnSpPr>
                <p:cNvPr id="101" name="Straight Arrow Connector 257"/>
                <p:cNvCxnSpPr/>
                <p:nvPr/>
              </p:nvCxnSpPr>
              <p:spPr>
                <a:xfrm flipH="1" flipV="1">
                  <a:off x="5697000" y="5405400"/>
                  <a:ext cx="354600" cy="864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tailEnd len="med" type="arrow" w="med"/>
                </a:ln>
              </p:spPr>
            </p:cxnSp>
          </p:grpSp>
          <p:cxnSp>
            <p:nvCxnSpPr>
              <p:cNvPr id="102" name="Straight Arrow Connector 200"/>
              <p:cNvCxnSpPr/>
              <p:nvPr/>
            </p:nvCxnSpPr>
            <p:spPr>
              <a:xfrm>
                <a:off x="3838680" y="2185560"/>
                <a:ext cx="11520" cy="6102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headEnd len="med" type="arrow" w="med"/>
                <a:tailEnd len="med" type="arrow" w="med"/>
              </a:ln>
            </p:spPr>
          </p:cxnSp>
        </p:grpSp>
        <p:cxnSp>
          <p:nvCxnSpPr>
            <p:cNvPr id="103" name="Straight Arrow Connector 196"/>
            <p:cNvCxnSpPr/>
            <p:nvPr/>
          </p:nvCxnSpPr>
          <p:spPr>
            <a:xfrm>
              <a:off x="2354040" y="5349960"/>
              <a:ext cx="729360" cy="165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04" name="Straight Arrow Connector 197"/>
            <p:cNvCxnSpPr/>
            <p:nvPr/>
          </p:nvCxnSpPr>
          <p:spPr>
            <a:xfrm>
              <a:off x="2354040" y="5524560"/>
              <a:ext cx="729360" cy="165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05" name="Straight Arrow Connector 198"/>
            <p:cNvCxnSpPr/>
            <p:nvPr/>
          </p:nvCxnSpPr>
          <p:spPr>
            <a:xfrm>
              <a:off x="2350800" y="5677200"/>
              <a:ext cx="729360" cy="165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18T08:12:09Z</dcterms:created>
  <dc:creator>radha</dc:creator>
  <dc:description/>
  <dc:language>en-US</dc:language>
  <cp:lastModifiedBy>bern09</cp:lastModifiedBy>
  <dcterms:modified xsi:type="dcterms:W3CDTF">2012-09-27T06:19:05Z</dcterms:modified>
  <cp:revision>2</cp:revision>
  <dc:subject/>
  <dc:title>Slide 1</dc:title>
</cp:coreProperties>
</file>